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E424E81C-71F4-8F77-1E32-2D22E5A78873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942356" y="1987053"/>
          <a:ext cx="4173689" cy="381031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1444709">
                  <a:extLst>
                    <a:ext uri="{9D8B030D-6E8A-4147-A177-3AD203B41FA5}">
                      <a16:colId xmlns:a16="http://schemas.microsoft.com/office/drawing/2014/main" val="2104470780"/>
                    </a:ext>
                  </a:extLst>
                </a:gridCol>
                <a:gridCol w="708917">
                  <a:extLst>
                    <a:ext uri="{9D8B030D-6E8A-4147-A177-3AD203B41FA5}">
                      <a16:colId xmlns:a16="http://schemas.microsoft.com/office/drawing/2014/main" val="3414641327"/>
                    </a:ext>
                  </a:extLst>
                </a:gridCol>
                <a:gridCol w="584347">
                  <a:extLst>
                    <a:ext uri="{9D8B030D-6E8A-4147-A177-3AD203B41FA5}">
                      <a16:colId xmlns:a16="http://schemas.microsoft.com/office/drawing/2014/main" val="4108215222"/>
                    </a:ext>
                  </a:extLst>
                </a:gridCol>
                <a:gridCol w="1435716">
                  <a:extLst>
                    <a:ext uri="{9D8B030D-6E8A-4147-A177-3AD203B41FA5}">
                      <a16:colId xmlns:a16="http://schemas.microsoft.com/office/drawing/2014/main" val="4063904863"/>
                    </a:ext>
                  </a:extLst>
                </a:gridCol>
              </a:tblGrid>
              <a:tr h="396554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 ID 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de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35490899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patient 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2a, Stage </a:t>
                      </a:r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b</a:t>
                      </a:r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113825400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patient 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3a NX, MX, Clark Stage I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535256083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patient 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2a N0 MX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540795479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ary patient 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3b cN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290118618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 patient 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3a N1a M0, Stage </a:t>
                      </a:r>
                      <a:r>
                        <a:rPr lang="en-US" sz="11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b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085404565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 patient 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ge I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893723430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 patient 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XNXM1D - Stage IV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674988709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static patient 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t"/>
                      <a:r>
                        <a:rPr lang="en-US" sz="11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3aN2cM0 - Staging III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7966550"/>
                  </a:ext>
                </a:extLst>
              </a:tr>
            </a:tbl>
          </a:graphicData>
        </a:graphic>
      </p:graphicFrame>
      <p:sp>
        <p:nvSpPr>
          <p:cNvPr id="9" name="Title 1">
            <a:extLst>
              <a:ext uri="{FF2B5EF4-FFF2-40B4-BE49-F238E27FC236}">
                <a16:creationId xmlns:a16="http://schemas.microsoft.com/office/drawing/2014/main" id="{2A086378-D1F1-8BB5-D6CB-11AF78E7E7A2}"/>
              </a:ext>
            </a:extLst>
          </p:cNvPr>
          <p:cNvSpPr txBox="1">
            <a:spLocks/>
          </p:cNvSpPr>
          <p:nvPr/>
        </p:nvSpPr>
        <p:spPr>
          <a:xfrm>
            <a:off x="2910826" y="1642561"/>
            <a:ext cx="4472667" cy="397042"/>
          </a:xfrm>
          <a:prstGeom prst="rect">
            <a:avLst/>
          </a:prstGeom>
        </p:spPr>
        <p:txBody>
          <a:bodyPr vert="horz" lIns="75438" tIns="37719" rIns="75438" bIns="37719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j-ea"/>
                <a:cs typeface="Arial" panose="020B0604020202020204" pitchFamily="34" charset="0"/>
              </a:rPr>
              <a:t>Patients’ clinical parameter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423194" y="608222"/>
            <a:ext cx="32120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Tabl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4</a:t>
            </a:r>
          </a:p>
        </p:txBody>
      </p:sp>
    </p:spTree>
    <p:extLst>
      <p:ext uri="{BB962C8B-B14F-4D97-AF65-F5344CB8AC3E}">
        <p14:creationId xmlns:p14="http://schemas.microsoft.com/office/powerpoint/2010/main" val="6575398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86</Words>
  <Application>Microsoft Office PowerPoint</Application>
  <PresentationFormat>Custom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17</cp:revision>
  <dcterms:created xsi:type="dcterms:W3CDTF">2024-11-19T17:14:58Z</dcterms:created>
  <dcterms:modified xsi:type="dcterms:W3CDTF">2024-11-19T17:43:37Z</dcterms:modified>
</cp:coreProperties>
</file>